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大島　康宏" userId="6cd17788-7cbe-4810-8850-b27cb4e1c2d8" providerId="ADAL" clId="{D9191A64-2A4B-4C7A-89C0-391BC1AB4E46}"/>
    <pc:docChg chg="modSld">
      <pc:chgData name="大島　康宏" userId="6cd17788-7cbe-4810-8850-b27cb4e1c2d8" providerId="ADAL" clId="{D9191A64-2A4B-4C7A-89C0-391BC1AB4E46}" dt="2021-11-02T11:13:13.981" v="15" actId="1076"/>
      <pc:docMkLst>
        <pc:docMk/>
      </pc:docMkLst>
      <pc:sldChg chg="addSp modSp mod">
        <pc:chgData name="大島　康宏" userId="6cd17788-7cbe-4810-8850-b27cb4e1c2d8" providerId="ADAL" clId="{D9191A64-2A4B-4C7A-89C0-391BC1AB4E46}" dt="2021-11-02T11:13:13.981" v="15" actId="1076"/>
        <pc:sldMkLst>
          <pc:docMk/>
          <pc:sldMk cId="897331775" sldId="256"/>
        </pc:sldMkLst>
        <pc:spChg chg="mod">
          <ac:chgData name="大島　康宏" userId="6cd17788-7cbe-4810-8850-b27cb4e1c2d8" providerId="ADAL" clId="{D9191A64-2A4B-4C7A-89C0-391BC1AB4E46}" dt="2021-11-02T11:13:12.093" v="14" actId="1076"/>
          <ac:spMkLst>
            <pc:docMk/>
            <pc:sldMk cId="897331775" sldId="256"/>
            <ac:spMk id="9" creationId="{F2AD3D44-24C1-4CFA-A622-DC8844FE92B9}"/>
          </ac:spMkLst>
        </pc:spChg>
        <pc:spChg chg="mod">
          <ac:chgData name="大島　康宏" userId="6cd17788-7cbe-4810-8850-b27cb4e1c2d8" providerId="ADAL" clId="{D9191A64-2A4B-4C7A-89C0-391BC1AB4E46}" dt="2021-11-02T11:13:13.981" v="15" actId="1076"/>
          <ac:spMkLst>
            <pc:docMk/>
            <pc:sldMk cId="897331775" sldId="256"/>
            <ac:spMk id="10" creationId="{EE7CD712-FD9A-4E5F-8B35-C464DC83FEF4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1" creationId="{612FCF42-4161-40C5-9C94-148E91594C3C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2" creationId="{845BE3F0-5164-4976-BEF6-5D340857BDD1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3" creationId="{F7F08544-C126-44D2-930A-0CFB084913D2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4" creationId="{F61567B1-6DCE-4FF3-9E31-3CC47EC25A0C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5" creationId="{FC865469-4C5B-4119-B378-298BD13BDB5D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6" creationId="{DD27DCCC-30B7-4B1B-A6FC-C72AB040BB9D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7" creationId="{68EA92CA-245F-496F-945B-66C960F2D6E4}"/>
          </ac:spMkLst>
        </pc:spChg>
        <pc:spChg chg="mod">
          <ac:chgData name="大島　康宏" userId="6cd17788-7cbe-4810-8850-b27cb4e1c2d8" providerId="ADAL" clId="{D9191A64-2A4B-4C7A-89C0-391BC1AB4E46}" dt="2021-11-02T11:12:55.637" v="12" actId="1076"/>
          <ac:spMkLst>
            <pc:docMk/>
            <pc:sldMk cId="897331775" sldId="256"/>
            <ac:spMk id="18" creationId="{BDA121F4-C3B0-4DAA-9F35-45C4206C5A45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19" creationId="{FE6A7263-4371-493E-8D12-016739C3D2D0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0" creationId="{DE9E59B2-0A6D-4013-8796-5B30332F8BBA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1" creationId="{710DD79F-283F-41CB-A265-5F63A2255567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2" creationId="{2C2F4D6E-53A3-4A47-B9EC-141D70E78494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3" creationId="{36976A5D-A67E-49EB-A6DB-834C9808537C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4" creationId="{BEE9FEAF-7BAC-427F-81CF-4752196B3EE0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5" creationId="{5F534A69-8164-4D63-8A79-3173FC236BCF}"/>
          </ac:spMkLst>
        </pc:spChg>
        <pc:spChg chg="mod">
          <ac:chgData name="大島　康宏" userId="6cd17788-7cbe-4810-8850-b27cb4e1c2d8" providerId="ADAL" clId="{D9191A64-2A4B-4C7A-89C0-391BC1AB4E46}" dt="2021-11-02T11:13:01.565" v="13" actId="1076"/>
          <ac:spMkLst>
            <pc:docMk/>
            <pc:sldMk cId="897331775" sldId="256"/>
            <ac:spMk id="26" creationId="{355DFB65-B492-4D43-95B6-81C114283395}"/>
          </ac:spMkLst>
        </pc:spChg>
        <pc:cxnChg chg="add mod">
          <ac:chgData name="大島　康宏" userId="6cd17788-7cbe-4810-8850-b27cb4e1c2d8" providerId="ADAL" clId="{D9191A64-2A4B-4C7A-89C0-391BC1AB4E46}" dt="2021-11-02T11:12:43.533" v="11" actId="1076"/>
          <ac:cxnSpMkLst>
            <pc:docMk/>
            <pc:sldMk cId="897331775" sldId="256"/>
            <ac:cxnSpMk id="28" creationId="{9D1B01EE-16A8-4CE0-A6BB-8C2F87E14E46}"/>
          </ac:cxnSpMkLst>
        </pc:cxnChg>
      </pc:sldChg>
      <pc:sldChg chg="addSp modSp mod">
        <pc:chgData name="大島　康宏" userId="6cd17788-7cbe-4810-8850-b27cb4e1c2d8" providerId="ADAL" clId="{D9191A64-2A4B-4C7A-89C0-391BC1AB4E46}" dt="2021-11-02T11:12:32.286" v="9" actId="208"/>
        <pc:sldMkLst>
          <pc:docMk/>
          <pc:sldMk cId="2386711024" sldId="257"/>
        </pc:sldMkLst>
        <pc:cxnChg chg="add mod">
          <ac:chgData name="大島　康宏" userId="6cd17788-7cbe-4810-8850-b27cb4e1c2d8" providerId="ADAL" clId="{D9191A64-2A4B-4C7A-89C0-391BC1AB4E46}" dt="2021-11-02T11:12:28.415" v="8" actId="208"/>
          <ac:cxnSpMkLst>
            <pc:docMk/>
            <pc:sldMk cId="2386711024" sldId="257"/>
            <ac:cxnSpMk id="238" creationId="{3E346C98-EBEB-4175-A5B1-C397B8B73243}"/>
          </ac:cxnSpMkLst>
        </pc:cxnChg>
        <pc:cxnChg chg="add mod">
          <ac:chgData name="大島　康宏" userId="6cd17788-7cbe-4810-8850-b27cb4e1c2d8" providerId="ADAL" clId="{D9191A64-2A4B-4C7A-89C0-391BC1AB4E46}" dt="2021-11-02T11:12:28.415" v="8" actId="208"/>
          <ac:cxnSpMkLst>
            <pc:docMk/>
            <pc:sldMk cId="2386711024" sldId="257"/>
            <ac:cxnSpMk id="239" creationId="{E7B10386-D0BF-4A7C-9440-2873E39C7361}"/>
          </ac:cxnSpMkLst>
        </pc:cxnChg>
        <pc:cxnChg chg="add mod">
          <ac:chgData name="大島　康宏" userId="6cd17788-7cbe-4810-8850-b27cb4e1c2d8" providerId="ADAL" clId="{D9191A64-2A4B-4C7A-89C0-391BC1AB4E46}" dt="2021-11-02T11:12:32.286" v="9" actId="208"/>
          <ac:cxnSpMkLst>
            <pc:docMk/>
            <pc:sldMk cId="2386711024" sldId="257"/>
            <ac:cxnSpMk id="240" creationId="{EDF5CABF-349E-4E2D-B30D-DBBADEF838C9}"/>
          </ac:cxnSpMkLst>
        </pc:cxnChg>
        <pc:cxnChg chg="add mod">
          <ac:chgData name="大島　康宏" userId="6cd17788-7cbe-4810-8850-b27cb4e1c2d8" providerId="ADAL" clId="{D9191A64-2A4B-4C7A-89C0-391BC1AB4E46}" dt="2021-11-02T11:12:32.286" v="9" actId="208"/>
          <ac:cxnSpMkLst>
            <pc:docMk/>
            <pc:sldMk cId="2386711024" sldId="257"/>
            <ac:cxnSpMk id="241" creationId="{209A071B-AC10-4C62-AB7C-AC67CEDCB6F8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A$3:$A$10</c:f>
              <c:strCache>
                <c:ptCount val="8"/>
                <c:pt idx="0">
                  <c:v>Tumor  1</c:v>
                </c:pt>
                <c:pt idx="1">
                  <c:v>Tumor  2</c:v>
                </c:pt>
                <c:pt idx="2">
                  <c:v>Tumor  3</c:v>
                </c:pt>
                <c:pt idx="3">
                  <c:v>Tumor  4</c:v>
                </c:pt>
                <c:pt idx="4">
                  <c:v>Tumor  5</c:v>
                </c:pt>
                <c:pt idx="5">
                  <c:v>Tumor  6</c:v>
                </c:pt>
                <c:pt idx="6">
                  <c:v>Tumor  7</c:v>
                </c:pt>
                <c:pt idx="7">
                  <c:v>Tumor  8</c:v>
                </c:pt>
              </c:strCache>
            </c:strRef>
          </c:cat>
          <c:val>
            <c:numRef>
              <c:f>Sheet1!$D$3:$D$10</c:f>
              <c:numCache>
                <c:formatCode>General</c:formatCode>
                <c:ptCount val="8"/>
                <c:pt idx="0">
                  <c:v>0.86466475154806</c:v>
                </c:pt>
                <c:pt idx="1">
                  <c:v>0.91035767807977064</c:v>
                </c:pt>
                <c:pt idx="2">
                  <c:v>0.53020127705027231</c:v>
                </c:pt>
                <c:pt idx="3">
                  <c:v>0.4543721338518858</c:v>
                </c:pt>
                <c:pt idx="4">
                  <c:v>0.54997802591511435</c:v>
                </c:pt>
                <c:pt idx="5">
                  <c:v>0.63369090553428009</c:v>
                </c:pt>
                <c:pt idx="6">
                  <c:v>0.51802027266118056</c:v>
                </c:pt>
                <c:pt idx="7">
                  <c:v>0.360291040856424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6F-480C-B751-E4FAB8B685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axId val="570001376"/>
        <c:axId val="563422992"/>
      </c:barChart>
      <c:catAx>
        <c:axId val="570001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3422992"/>
        <c:crosses val="autoZero"/>
        <c:auto val="1"/>
        <c:lblAlgn val="ctr"/>
        <c:lblOffset val="100"/>
        <c:noMultiLvlLbl val="0"/>
      </c:catAx>
      <c:valAx>
        <c:axId val="563422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ensity ratio (LAT1/β-act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000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A$3:$A$6</c:f>
              <c:strCache>
                <c:ptCount val="4"/>
                <c:pt idx="0">
                  <c:v>control</c:v>
                </c:pt>
                <c:pt idx="1">
                  <c:v>1 h</c:v>
                </c:pt>
                <c:pt idx="2">
                  <c:v>3 h</c:v>
                </c:pt>
                <c:pt idx="3">
                  <c:v>6 h</c:v>
                </c:pt>
              </c:strCache>
            </c:strRef>
          </c:cat>
          <c:val>
            <c:numRef>
              <c:f>Sheet1!$D$3:$D$6</c:f>
              <c:numCache>
                <c:formatCode>General</c:formatCode>
                <c:ptCount val="4"/>
                <c:pt idx="0">
                  <c:v>1.0344957939905162</c:v>
                </c:pt>
                <c:pt idx="1">
                  <c:v>0.94063850999899279</c:v>
                </c:pt>
                <c:pt idx="2">
                  <c:v>0.8426523969094798</c:v>
                </c:pt>
                <c:pt idx="3">
                  <c:v>1.05404297623509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36-447C-ADB6-413A79E34C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axId val="570001376"/>
        <c:axId val="563422992"/>
      </c:barChart>
      <c:catAx>
        <c:axId val="570001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3422992"/>
        <c:crosses val="autoZero"/>
        <c:auto val="1"/>
        <c:lblAlgn val="ctr"/>
        <c:lblOffset val="100"/>
        <c:noMultiLvlLbl val="0"/>
      </c:catAx>
      <c:valAx>
        <c:axId val="563422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ensity ratio (LAT1/β-act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000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A$9:$A$12</c:f>
              <c:strCache>
                <c:ptCount val="4"/>
                <c:pt idx="0">
                  <c:v>control</c:v>
                </c:pt>
                <c:pt idx="1">
                  <c:v>1 h</c:v>
                </c:pt>
                <c:pt idx="2">
                  <c:v>3 h</c:v>
                </c:pt>
                <c:pt idx="3">
                  <c:v>6 h</c:v>
                </c:pt>
              </c:strCache>
            </c:strRef>
          </c:cat>
          <c:val>
            <c:numRef>
              <c:f>Sheet1!$D$9:$D$12</c:f>
              <c:numCache>
                <c:formatCode>General</c:formatCode>
                <c:ptCount val="4"/>
                <c:pt idx="0">
                  <c:v>0.51053861062297667</c:v>
                </c:pt>
                <c:pt idx="1">
                  <c:v>0.38367901002609039</c:v>
                </c:pt>
                <c:pt idx="2">
                  <c:v>0.39178952592459748</c:v>
                </c:pt>
                <c:pt idx="3">
                  <c:v>0.57069655373967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72-41CF-8057-67BCF75041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axId val="570001376"/>
        <c:axId val="563422992"/>
      </c:barChart>
      <c:catAx>
        <c:axId val="570001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3422992"/>
        <c:crosses val="autoZero"/>
        <c:auto val="1"/>
        <c:lblAlgn val="ctr"/>
        <c:lblOffset val="100"/>
        <c:noMultiLvlLbl val="0"/>
      </c:catAx>
      <c:valAx>
        <c:axId val="563422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ensity ratio (LAT1/β-act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000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A$15:$A$18</c:f>
              <c:strCache>
                <c:ptCount val="4"/>
                <c:pt idx="0">
                  <c:v>control</c:v>
                </c:pt>
                <c:pt idx="1">
                  <c:v>1 h</c:v>
                </c:pt>
                <c:pt idx="2">
                  <c:v>3 h</c:v>
                </c:pt>
                <c:pt idx="3">
                  <c:v>6 h</c:v>
                </c:pt>
              </c:strCache>
            </c:strRef>
          </c:cat>
          <c:val>
            <c:numRef>
              <c:f>Sheet1!$D$15:$D$18</c:f>
              <c:numCache>
                <c:formatCode>General</c:formatCode>
                <c:ptCount val="4"/>
                <c:pt idx="0">
                  <c:v>1.2025093989475655</c:v>
                </c:pt>
                <c:pt idx="1">
                  <c:v>1.1622355573306344</c:v>
                </c:pt>
                <c:pt idx="2">
                  <c:v>1.4293097759953384</c:v>
                </c:pt>
                <c:pt idx="3">
                  <c:v>1.22788555482930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0E-4F56-9375-A3E4B141EF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axId val="570001376"/>
        <c:axId val="563422992"/>
      </c:barChart>
      <c:catAx>
        <c:axId val="570001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3422992"/>
        <c:crosses val="autoZero"/>
        <c:auto val="1"/>
        <c:lblAlgn val="ctr"/>
        <c:lblOffset val="100"/>
        <c:noMultiLvlLbl val="0"/>
      </c:catAx>
      <c:valAx>
        <c:axId val="563422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ensity ratio (LAT1/β-act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000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Sheet1!$A$21:$A$24</c:f>
              <c:strCache>
                <c:ptCount val="4"/>
                <c:pt idx="0">
                  <c:v>control</c:v>
                </c:pt>
                <c:pt idx="1">
                  <c:v>1 h</c:v>
                </c:pt>
                <c:pt idx="2">
                  <c:v>3 h</c:v>
                </c:pt>
                <c:pt idx="3">
                  <c:v>6 h</c:v>
                </c:pt>
              </c:strCache>
            </c:strRef>
          </c:cat>
          <c:val>
            <c:numRef>
              <c:f>Sheet1!$D$21:$D$24</c:f>
              <c:numCache>
                <c:formatCode>General</c:formatCode>
                <c:ptCount val="4"/>
                <c:pt idx="0">
                  <c:v>0.31502515726804708</c:v>
                </c:pt>
                <c:pt idx="1">
                  <c:v>0.44307656182466515</c:v>
                </c:pt>
                <c:pt idx="2">
                  <c:v>0.41733628178136684</c:v>
                </c:pt>
                <c:pt idx="3">
                  <c:v>0.51327270926029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B6-4AEE-AED4-9ADCCAD0B7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axId val="570001376"/>
        <c:axId val="563422992"/>
      </c:barChart>
      <c:catAx>
        <c:axId val="570001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63422992"/>
        <c:crosses val="autoZero"/>
        <c:auto val="1"/>
        <c:lblAlgn val="ctr"/>
        <c:lblOffset val="100"/>
        <c:noMultiLvlLbl val="0"/>
      </c:catAx>
      <c:valAx>
        <c:axId val="563422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Density ratio (LAT1/β-act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0001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899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27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754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377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552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132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046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6643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423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780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464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FA712-305D-4B1D-B56C-7405CD64B92E}" type="datetimeFigureOut">
              <a:rPr kumimoji="1" lang="ja-JP" altLang="en-US" smtClean="0"/>
              <a:t>2021/11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3145B-A38F-4294-BE60-403783112B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755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7" Type="http://schemas.openxmlformats.org/officeDocument/2006/relationships/image" Target="../media/image8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"/><Relationship Id="rId5" Type="http://schemas.openxmlformats.org/officeDocument/2006/relationships/image" Target="../media/image6.tif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0E60458-6E03-450D-9A09-9135FB5995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6622432"/>
              </p:ext>
            </p:extLst>
          </p:nvPr>
        </p:nvGraphicFramePr>
        <p:xfrm>
          <a:off x="1869101" y="4789249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図 5" descr="ブラシ, タオル が含まれている画像&#10;&#10;自動的に生成された説明">
            <a:extLst>
              <a:ext uri="{FF2B5EF4-FFF2-40B4-BE49-F238E27FC236}">
                <a16:creationId xmlns:a16="http://schemas.microsoft.com/office/drawing/2014/main" id="{CC975FF6-8393-4E54-98FF-DA4CC8AD0D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099" y="1811902"/>
            <a:ext cx="2657224" cy="22961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 descr="白い背景に黒い文字&#10;&#10;中程度の精度で自動的に生成された説明">
            <a:extLst>
              <a:ext uri="{FF2B5EF4-FFF2-40B4-BE49-F238E27FC236}">
                <a16:creationId xmlns:a16="http://schemas.microsoft.com/office/drawing/2014/main" id="{3A6B2382-B20C-4603-AD1B-824BC49A38E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1839678"/>
            <a:ext cx="2805362" cy="22683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2AD3D44-24C1-4CFA-A622-DC8844FE92B9}"/>
              </a:ext>
            </a:extLst>
          </p:cNvPr>
          <p:cNvSpPr txBox="1"/>
          <p:nvPr/>
        </p:nvSpPr>
        <p:spPr>
          <a:xfrm>
            <a:off x="269827" y="1302570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AT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7CD712-FD9A-4E5F-8B35-C464DC83FEF4}"/>
              </a:ext>
            </a:extLst>
          </p:cNvPr>
          <p:cNvSpPr txBox="1"/>
          <p:nvPr/>
        </p:nvSpPr>
        <p:spPr>
          <a:xfrm>
            <a:off x="3404739" y="1302570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12FCF42-4161-40C5-9C94-148E91594C3C}"/>
              </a:ext>
            </a:extLst>
          </p:cNvPr>
          <p:cNvSpPr txBox="1"/>
          <p:nvPr/>
        </p:nvSpPr>
        <p:spPr>
          <a:xfrm rot="18000000">
            <a:off x="788335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45BE3F0-5164-4976-BEF6-5D340857BDD1}"/>
              </a:ext>
            </a:extLst>
          </p:cNvPr>
          <p:cNvSpPr txBox="1"/>
          <p:nvPr/>
        </p:nvSpPr>
        <p:spPr>
          <a:xfrm rot="18000000">
            <a:off x="1016751" y="1400565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7F08544-C126-44D2-930A-0CFB084913D2}"/>
              </a:ext>
            </a:extLst>
          </p:cNvPr>
          <p:cNvSpPr txBox="1"/>
          <p:nvPr/>
        </p:nvSpPr>
        <p:spPr>
          <a:xfrm rot="18000000">
            <a:off x="1245167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61567B1-6DCE-4FF3-9E31-3CC47EC25A0C}"/>
              </a:ext>
            </a:extLst>
          </p:cNvPr>
          <p:cNvSpPr txBox="1"/>
          <p:nvPr/>
        </p:nvSpPr>
        <p:spPr>
          <a:xfrm rot="18000000">
            <a:off x="1473583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C865469-4C5B-4119-B378-298BD13BDB5D}"/>
              </a:ext>
            </a:extLst>
          </p:cNvPr>
          <p:cNvSpPr txBox="1"/>
          <p:nvPr/>
        </p:nvSpPr>
        <p:spPr>
          <a:xfrm rot="18000000">
            <a:off x="1701999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D27DCCC-30B7-4B1B-A6FC-C72AB040BB9D}"/>
              </a:ext>
            </a:extLst>
          </p:cNvPr>
          <p:cNvSpPr txBox="1"/>
          <p:nvPr/>
        </p:nvSpPr>
        <p:spPr>
          <a:xfrm rot="18000000">
            <a:off x="1930415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6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8EA92CA-245F-496F-945B-66C960F2D6E4}"/>
              </a:ext>
            </a:extLst>
          </p:cNvPr>
          <p:cNvSpPr txBox="1"/>
          <p:nvPr/>
        </p:nvSpPr>
        <p:spPr>
          <a:xfrm rot="18000000">
            <a:off x="2158831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7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DA121F4-C3B0-4DAA-9F35-45C4206C5A45}"/>
              </a:ext>
            </a:extLst>
          </p:cNvPr>
          <p:cNvSpPr txBox="1"/>
          <p:nvPr/>
        </p:nvSpPr>
        <p:spPr>
          <a:xfrm rot="18000000">
            <a:off x="2387250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E6A7263-4371-493E-8D12-016739C3D2D0}"/>
              </a:ext>
            </a:extLst>
          </p:cNvPr>
          <p:cNvSpPr txBox="1"/>
          <p:nvPr/>
        </p:nvSpPr>
        <p:spPr>
          <a:xfrm rot="18000000">
            <a:off x="3856479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E9E59B2-0A6D-4013-8796-5B30332F8BBA}"/>
              </a:ext>
            </a:extLst>
          </p:cNvPr>
          <p:cNvSpPr txBox="1"/>
          <p:nvPr/>
        </p:nvSpPr>
        <p:spPr>
          <a:xfrm rot="18000000">
            <a:off x="4084895" y="1400566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10DD79F-283F-41CB-A265-5F63A2255567}"/>
              </a:ext>
            </a:extLst>
          </p:cNvPr>
          <p:cNvSpPr txBox="1"/>
          <p:nvPr/>
        </p:nvSpPr>
        <p:spPr>
          <a:xfrm rot="18000000">
            <a:off x="4313311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C2F4D6E-53A3-4A47-B9EC-141D70E78494}"/>
              </a:ext>
            </a:extLst>
          </p:cNvPr>
          <p:cNvSpPr txBox="1"/>
          <p:nvPr/>
        </p:nvSpPr>
        <p:spPr>
          <a:xfrm rot="18000000">
            <a:off x="4541727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6976A5D-A67E-49EB-A6DB-834C9808537C}"/>
              </a:ext>
            </a:extLst>
          </p:cNvPr>
          <p:cNvSpPr txBox="1"/>
          <p:nvPr/>
        </p:nvSpPr>
        <p:spPr>
          <a:xfrm rot="18000000">
            <a:off x="4770143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EE9FEAF-7BAC-427F-81CF-4752196B3EE0}"/>
              </a:ext>
            </a:extLst>
          </p:cNvPr>
          <p:cNvSpPr txBox="1"/>
          <p:nvPr/>
        </p:nvSpPr>
        <p:spPr>
          <a:xfrm rot="18000000">
            <a:off x="4998559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6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F534A69-8164-4D63-8A79-3173FC236BCF}"/>
              </a:ext>
            </a:extLst>
          </p:cNvPr>
          <p:cNvSpPr txBox="1"/>
          <p:nvPr/>
        </p:nvSpPr>
        <p:spPr>
          <a:xfrm rot="18000000">
            <a:off x="5226975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7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55DFB65-B492-4D43-95B6-81C114283395}"/>
              </a:ext>
            </a:extLst>
          </p:cNvPr>
          <p:cNvSpPr txBox="1"/>
          <p:nvPr/>
        </p:nvSpPr>
        <p:spPr>
          <a:xfrm rot="18000000">
            <a:off x="5455394" y="140056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umor 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5FC524A-4666-4D03-B88D-186E7EBCB0C8}"/>
              </a:ext>
            </a:extLst>
          </p:cNvPr>
          <p:cNvSpPr txBox="1"/>
          <p:nvPr/>
        </p:nvSpPr>
        <p:spPr>
          <a:xfrm>
            <a:off x="257649" y="243403"/>
            <a:ext cx="21483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sults of western blot (Tumor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9D1B01EE-16A8-4CE0-A6BB-8C2F87E14E46}"/>
              </a:ext>
            </a:extLst>
          </p:cNvPr>
          <p:cNvCxnSpPr>
            <a:cxnSpLocks/>
          </p:cNvCxnSpPr>
          <p:nvPr/>
        </p:nvCxnSpPr>
        <p:spPr>
          <a:xfrm flipH="1">
            <a:off x="3176323" y="3086478"/>
            <a:ext cx="2173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973317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建物, 水, 写真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454EC84B-5D77-4ACA-8930-E6CAE41756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291" y="1364477"/>
            <a:ext cx="2520000" cy="20910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 descr="白黒の写真&#10;&#10;低い精度で自動的に生成された説明">
            <a:extLst>
              <a:ext uri="{FF2B5EF4-FFF2-40B4-BE49-F238E27FC236}">
                <a16:creationId xmlns:a16="http://schemas.microsoft.com/office/drawing/2014/main" id="{CFBA5664-5AA2-450E-A539-5636CEE8EB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7558" y="1407117"/>
            <a:ext cx="2592000" cy="19660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01A6159-3088-43C4-BABA-066F0FF9856A}"/>
              </a:ext>
            </a:extLst>
          </p:cNvPr>
          <p:cNvSpPr txBox="1"/>
          <p:nvPr/>
        </p:nvSpPr>
        <p:spPr>
          <a:xfrm>
            <a:off x="126074" y="371372"/>
            <a:ext cx="830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AT1-1s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608D493-E294-41CE-9F5E-C768A4CCD375}"/>
              </a:ext>
            </a:extLst>
          </p:cNvPr>
          <p:cNvSpPr txBox="1"/>
          <p:nvPr/>
        </p:nvSpPr>
        <p:spPr>
          <a:xfrm>
            <a:off x="1147141" y="353984"/>
            <a:ext cx="6415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53FF633-E848-402C-A856-7CD7A3A861FA}"/>
              </a:ext>
            </a:extLst>
          </p:cNvPr>
          <p:cNvSpPr txBox="1"/>
          <p:nvPr/>
        </p:nvSpPr>
        <p:spPr>
          <a:xfrm>
            <a:off x="5098872" y="373933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7918D12-CD42-4D13-BEE3-1F06ED5E348E}"/>
              </a:ext>
            </a:extLst>
          </p:cNvPr>
          <p:cNvSpPr txBox="1"/>
          <p:nvPr/>
        </p:nvSpPr>
        <p:spPr>
          <a:xfrm>
            <a:off x="2234787" y="342443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S180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ECC9C23-B254-41E3-917F-824787D5DE63}"/>
              </a:ext>
            </a:extLst>
          </p:cNvPr>
          <p:cNvSpPr txBox="1"/>
          <p:nvPr/>
        </p:nvSpPr>
        <p:spPr>
          <a:xfrm>
            <a:off x="3954895" y="373291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U87MG</a:t>
            </a:r>
          </a:p>
        </p:txBody>
      </p: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52429C62-545F-423C-A0B6-82B10D8FC819}"/>
              </a:ext>
            </a:extLst>
          </p:cNvPr>
          <p:cNvGrpSpPr/>
          <p:nvPr/>
        </p:nvGrpSpPr>
        <p:grpSpPr>
          <a:xfrm>
            <a:off x="936535" y="559582"/>
            <a:ext cx="1134048" cy="809315"/>
            <a:chOff x="936535" y="290821"/>
            <a:chExt cx="1134048" cy="809315"/>
          </a:xfrm>
        </p:grpSpPr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7FD7C3E9-6DCB-4B21-ACF2-45D772EBAE38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6FE0AA6D-99B2-4C71-AA11-34E6F7DF5796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4CF26DEA-0767-4D41-8175-5B2D07C1963F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3D75FD8E-859F-49F3-B53C-91622A74528A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9BED9D77-49CD-41F3-9354-F952597ECF8A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右大かっこ 25">
              <a:extLst>
                <a:ext uri="{FF2B5EF4-FFF2-40B4-BE49-F238E27FC236}">
                  <a16:creationId xmlns:a16="http://schemas.microsoft.com/office/drawing/2014/main" id="{9E153F8B-BA9E-42D4-B432-4AC7B6340F15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grpSp>
        <p:nvGrpSpPr>
          <p:cNvPr id="157" name="グループ化 156">
            <a:extLst>
              <a:ext uri="{FF2B5EF4-FFF2-40B4-BE49-F238E27FC236}">
                <a16:creationId xmlns:a16="http://schemas.microsoft.com/office/drawing/2014/main" id="{6E361FC6-9C6C-4AA3-B5A9-F5DD15BB9662}"/>
              </a:ext>
            </a:extLst>
          </p:cNvPr>
          <p:cNvGrpSpPr/>
          <p:nvPr/>
        </p:nvGrpSpPr>
        <p:grpSpPr>
          <a:xfrm>
            <a:off x="1938885" y="559582"/>
            <a:ext cx="1134048" cy="809315"/>
            <a:chOff x="936535" y="290821"/>
            <a:chExt cx="1134048" cy="809315"/>
          </a:xfrm>
        </p:grpSpPr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AE9BBAC4-A369-4B22-AE26-4A429C6B42D1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E8F34A4C-F8BF-4593-91FB-7B0935F0C140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DA1639F9-17DA-4947-AC98-B274516C393C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E4D11848-4489-446E-8FC4-569A3A98EF6B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0DEA078B-B717-4043-94FB-1DD6F6D418E6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右大かっこ 162">
              <a:extLst>
                <a:ext uri="{FF2B5EF4-FFF2-40B4-BE49-F238E27FC236}">
                  <a16:creationId xmlns:a16="http://schemas.microsoft.com/office/drawing/2014/main" id="{2EE4C604-5CFA-43AE-98FC-BCE6F05E0876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F44AE959-7D88-445C-8FAA-312706BA436D}"/>
              </a:ext>
            </a:extLst>
          </p:cNvPr>
          <p:cNvGrpSpPr/>
          <p:nvPr/>
        </p:nvGrpSpPr>
        <p:grpSpPr>
          <a:xfrm>
            <a:off x="3813266" y="592809"/>
            <a:ext cx="1134048" cy="809315"/>
            <a:chOff x="936535" y="290821"/>
            <a:chExt cx="1134048" cy="809315"/>
          </a:xfrm>
        </p:grpSpPr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62E8EA5F-FDC6-4878-B7E0-7DBAEDFEC85D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FE47F15C-256B-4E8F-98A7-3D3F6D5EDCA8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B8B8BC46-017F-48C7-A717-A4C90CCF229B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FD37A270-17B3-4B38-8242-8E80F1536BE9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879F938B-E0D5-469F-A144-D733C8E70C93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右大かっこ 169">
              <a:extLst>
                <a:ext uri="{FF2B5EF4-FFF2-40B4-BE49-F238E27FC236}">
                  <a16:creationId xmlns:a16="http://schemas.microsoft.com/office/drawing/2014/main" id="{77C90A28-58AA-4372-8E93-031BBDC330D0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grpSp>
        <p:nvGrpSpPr>
          <p:cNvPr id="171" name="グループ化 170">
            <a:extLst>
              <a:ext uri="{FF2B5EF4-FFF2-40B4-BE49-F238E27FC236}">
                <a16:creationId xmlns:a16="http://schemas.microsoft.com/office/drawing/2014/main" id="{A78F03B1-12C4-4715-818B-2031F4B22958}"/>
              </a:ext>
            </a:extLst>
          </p:cNvPr>
          <p:cNvGrpSpPr/>
          <p:nvPr/>
        </p:nvGrpSpPr>
        <p:grpSpPr>
          <a:xfrm>
            <a:off x="4836300" y="592809"/>
            <a:ext cx="1134048" cy="809315"/>
            <a:chOff x="936535" y="290821"/>
            <a:chExt cx="1134048" cy="809315"/>
          </a:xfrm>
        </p:grpSpPr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93F0B60D-4C9F-4466-8DB0-375D0EB0BBC9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1450002E-6654-4BB6-9ACC-6DB6AA66F59E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11DFDCAA-58E9-4438-93DB-DCF0E9B98C10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514D154A-EEB1-45A6-8B08-33B8FDF32EF8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D9BFB430-67AE-49CB-BFEE-52CD72AB14D6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右大かっこ 176">
              <a:extLst>
                <a:ext uri="{FF2B5EF4-FFF2-40B4-BE49-F238E27FC236}">
                  <a16:creationId xmlns:a16="http://schemas.microsoft.com/office/drawing/2014/main" id="{D6B4C4C8-71F1-46FF-A32A-578B064350A2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pic>
        <p:nvPicPr>
          <p:cNvPr id="79" name="図 78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5D71655C-A805-4736-8FA2-AEAF0C3811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0158" y="7958672"/>
            <a:ext cx="2700000" cy="18815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A1CB4A0-CA26-4D0E-9618-9C6F9988B694}"/>
              </a:ext>
            </a:extLst>
          </p:cNvPr>
          <p:cNvSpPr txBox="1"/>
          <p:nvPr/>
        </p:nvSpPr>
        <p:spPr>
          <a:xfrm>
            <a:off x="121768" y="6648779"/>
            <a:ext cx="3659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AT1-2nd. The same samples were re-analyzed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5" name="図 154" descr="立つ, キッチン, 探す, 座る が含まれている画像&#10;&#10;自動的に生成された説明">
            <a:extLst>
              <a:ext uri="{FF2B5EF4-FFF2-40B4-BE49-F238E27FC236}">
                <a16:creationId xmlns:a16="http://schemas.microsoft.com/office/drawing/2014/main" id="{B4BF0124-5BAB-4AB9-A8C5-C4A2C05CA09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057" y="7942194"/>
            <a:ext cx="2700000" cy="19382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95C2251E-B078-4D5B-8952-788AF83591CA}"/>
              </a:ext>
            </a:extLst>
          </p:cNvPr>
          <p:cNvSpPr txBox="1"/>
          <p:nvPr/>
        </p:nvSpPr>
        <p:spPr>
          <a:xfrm>
            <a:off x="4207440" y="6917289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U87MG</a:t>
            </a:r>
          </a:p>
        </p:txBody>
      </p:sp>
      <p:grpSp>
        <p:nvGrpSpPr>
          <p:cNvPr id="179" name="グループ化 178">
            <a:extLst>
              <a:ext uri="{FF2B5EF4-FFF2-40B4-BE49-F238E27FC236}">
                <a16:creationId xmlns:a16="http://schemas.microsoft.com/office/drawing/2014/main" id="{43CB754A-B091-4E3D-B1BB-63893A4C57D5}"/>
              </a:ext>
            </a:extLst>
          </p:cNvPr>
          <p:cNvGrpSpPr/>
          <p:nvPr/>
        </p:nvGrpSpPr>
        <p:grpSpPr>
          <a:xfrm>
            <a:off x="4065811" y="7169015"/>
            <a:ext cx="1134048" cy="809315"/>
            <a:chOff x="936535" y="290821"/>
            <a:chExt cx="1134048" cy="809315"/>
          </a:xfrm>
        </p:grpSpPr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C08648D7-93E2-437B-8EAF-CA0D32722FC5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047E5E74-D416-4398-86E3-7D6600676FA3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5392C7AA-4675-4AD6-AE04-0D55F0738687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34BF4D9F-D8C4-4DF8-83D7-593EB6F7F881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7CADAF7F-54DA-46E0-BDA1-65D80C00E098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右大かっこ 184">
              <a:extLst>
                <a:ext uri="{FF2B5EF4-FFF2-40B4-BE49-F238E27FC236}">
                  <a16:creationId xmlns:a16="http://schemas.microsoft.com/office/drawing/2014/main" id="{F842EDCE-C01C-4CA6-9907-6B635B006AEC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8BFA59A7-B863-4470-BA6A-64B0A5AFE2A6}"/>
              </a:ext>
            </a:extLst>
          </p:cNvPr>
          <p:cNvSpPr txBox="1"/>
          <p:nvPr/>
        </p:nvSpPr>
        <p:spPr>
          <a:xfrm>
            <a:off x="1260294" y="6917289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S180</a:t>
            </a:r>
          </a:p>
        </p:txBody>
      </p:sp>
      <p:grpSp>
        <p:nvGrpSpPr>
          <p:cNvPr id="187" name="グループ化 186">
            <a:extLst>
              <a:ext uri="{FF2B5EF4-FFF2-40B4-BE49-F238E27FC236}">
                <a16:creationId xmlns:a16="http://schemas.microsoft.com/office/drawing/2014/main" id="{3DA0FCC9-D0B5-431A-8038-EE5826C305E1}"/>
              </a:ext>
            </a:extLst>
          </p:cNvPr>
          <p:cNvGrpSpPr/>
          <p:nvPr/>
        </p:nvGrpSpPr>
        <p:grpSpPr>
          <a:xfrm>
            <a:off x="964392" y="7169015"/>
            <a:ext cx="1134048" cy="809315"/>
            <a:chOff x="936535" y="290821"/>
            <a:chExt cx="1134048" cy="809315"/>
          </a:xfrm>
        </p:grpSpPr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4787214B-095A-4200-8524-A71267882785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574D8556-DEE9-49F6-95C8-30C86351D4E6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CF202B27-0577-44C3-9285-5D2E3D304D83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EA72FC02-813A-435E-B293-B98A39B63983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494D592B-F2A2-4CA2-B0E1-FF3E185287DF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右大かっこ 192">
              <a:extLst>
                <a:ext uri="{FF2B5EF4-FFF2-40B4-BE49-F238E27FC236}">
                  <a16:creationId xmlns:a16="http://schemas.microsoft.com/office/drawing/2014/main" id="{0E8560A3-3BC6-4E4E-B521-0A63F3B844FF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5F3077F6-575C-4E0E-BCEB-A0FF97F99812}"/>
              </a:ext>
            </a:extLst>
          </p:cNvPr>
          <p:cNvSpPr txBox="1"/>
          <p:nvPr/>
        </p:nvSpPr>
        <p:spPr>
          <a:xfrm>
            <a:off x="2199903" y="6917289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grpSp>
        <p:nvGrpSpPr>
          <p:cNvPr id="195" name="グループ化 194">
            <a:extLst>
              <a:ext uri="{FF2B5EF4-FFF2-40B4-BE49-F238E27FC236}">
                <a16:creationId xmlns:a16="http://schemas.microsoft.com/office/drawing/2014/main" id="{EE462923-F610-4A0B-BCE6-AF9BAC881AEE}"/>
              </a:ext>
            </a:extLst>
          </p:cNvPr>
          <p:cNvGrpSpPr/>
          <p:nvPr/>
        </p:nvGrpSpPr>
        <p:grpSpPr>
          <a:xfrm>
            <a:off x="1937331" y="7169015"/>
            <a:ext cx="1134048" cy="809315"/>
            <a:chOff x="936535" y="290821"/>
            <a:chExt cx="1134048" cy="809315"/>
          </a:xfrm>
        </p:grpSpPr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69C6402C-57DD-475E-9B88-4DEBB143B946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9602EEDD-FBC2-4872-ADCE-6CD958612D00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31B95C83-988D-4795-B3B0-A41359E43B04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E00F9F7F-B625-4A9D-9B41-77C358FBF597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DEF2BCE0-3371-4FEF-BEB0-89A6F2E1690A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右大かっこ 200">
              <a:extLst>
                <a:ext uri="{FF2B5EF4-FFF2-40B4-BE49-F238E27FC236}">
                  <a16:creationId xmlns:a16="http://schemas.microsoft.com/office/drawing/2014/main" id="{9BE4E21A-3551-4C49-A860-337B7447720B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5B1FC35-FBB4-47B5-B2CC-FBC2F53C2B41}"/>
              </a:ext>
            </a:extLst>
          </p:cNvPr>
          <p:cNvSpPr txBox="1"/>
          <p:nvPr/>
        </p:nvSpPr>
        <p:spPr>
          <a:xfrm>
            <a:off x="160240" y="3571613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図 97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767CF01E-E50F-400F-956B-07F520C21C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0158" y="4547791"/>
            <a:ext cx="2700000" cy="20294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図 99" descr="白い背景に黒い文字がある&#10;&#10;中程度の精度で自動的に生成された説明">
            <a:extLst>
              <a:ext uri="{FF2B5EF4-FFF2-40B4-BE49-F238E27FC236}">
                <a16:creationId xmlns:a16="http://schemas.microsoft.com/office/drawing/2014/main" id="{1107A407-8F56-447C-A0C2-EED1747A91B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166" y="4557775"/>
            <a:ext cx="2700000" cy="20140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B6A8E552-A475-4CD5-AD3F-1A1F2F9E72EE}"/>
              </a:ext>
            </a:extLst>
          </p:cNvPr>
          <p:cNvSpPr txBox="1"/>
          <p:nvPr/>
        </p:nvSpPr>
        <p:spPr>
          <a:xfrm>
            <a:off x="1013692" y="3548126"/>
            <a:ext cx="6415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88D2A402-133A-4227-AE23-C77B8AAA92A1}"/>
              </a:ext>
            </a:extLst>
          </p:cNvPr>
          <p:cNvSpPr txBox="1"/>
          <p:nvPr/>
        </p:nvSpPr>
        <p:spPr>
          <a:xfrm>
            <a:off x="2101338" y="3536585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S180</a:t>
            </a:r>
          </a:p>
        </p:txBody>
      </p:sp>
      <p:grpSp>
        <p:nvGrpSpPr>
          <p:cNvPr id="204" name="グループ化 203">
            <a:extLst>
              <a:ext uri="{FF2B5EF4-FFF2-40B4-BE49-F238E27FC236}">
                <a16:creationId xmlns:a16="http://schemas.microsoft.com/office/drawing/2014/main" id="{53632DA0-4C2B-45D4-A734-C7E63F063CA4}"/>
              </a:ext>
            </a:extLst>
          </p:cNvPr>
          <p:cNvGrpSpPr/>
          <p:nvPr/>
        </p:nvGrpSpPr>
        <p:grpSpPr>
          <a:xfrm>
            <a:off x="803086" y="3753724"/>
            <a:ext cx="1134048" cy="809315"/>
            <a:chOff x="936535" y="290821"/>
            <a:chExt cx="1134048" cy="809315"/>
          </a:xfrm>
        </p:grpSpPr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F0382441-B91C-4AA7-9674-EA0FBEBCCD3B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2ED4F8F5-7BEF-4368-9FA8-32D074BF40CF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066C2510-F469-481F-965A-C5337393F4DF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EF022A77-08AB-40B0-9BC1-024686330F27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8DB09EE9-7595-42BB-AC26-3E51258F6552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右大かっこ 209">
              <a:extLst>
                <a:ext uri="{FF2B5EF4-FFF2-40B4-BE49-F238E27FC236}">
                  <a16:creationId xmlns:a16="http://schemas.microsoft.com/office/drawing/2014/main" id="{A4D04DDE-4FB9-4C8A-B0FF-8E164220DEED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grpSp>
        <p:nvGrpSpPr>
          <p:cNvPr id="211" name="グループ化 210">
            <a:extLst>
              <a:ext uri="{FF2B5EF4-FFF2-40B4-BE49-F238E27FC236}">
                <a16:creationId xmlns:a16="http://schemas.microsoft.com/office/drawing/2014/main" id="{529E8173-6D8D-47E8-9805-CD2C92DAF57A}"/>
              </a:ext>
            </a:extLst>
          </p:cNvPr>
          <p:cNvGrpSpPr/>
          <p:nvPr/>
        </p:nvGrpSpPr>
        <p:grpSpPr>
          <a:xfrm>
            <a:off x="1805436" y="3753724"/>
            <a:ext cx="1134048" cy="809315"/>
            <a:chOff x="936535" y="290821"/>
            <a:chExt cx="1134048" cy="809315"/>
          </a:xfrm>
        </p:grpSpPr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2FB02794-A7C5-4675-B22A-CEB1B02276E1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A2403E11-961E-450B-B641-344EB521C67A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4E5C809D-98F1-40CC-BABD-4664C4874557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A733E160-161F-43D8-9401-5593460F61CC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C8A8E668-66FE-410D-9BCF-0604E52647D6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右大かっこ 216">
              <a:extLst>
                <a:ext uri="{FF2B5EF4-FFF2-40B4-BE49-F238E27FC236}">
                  <a16:creationId xmlns:a16="http://schemas.microsoft.com/office/drawing/2014/main" id="{2E4214A7-9744-4D7C-8C34-DEB39019C2F2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56F7B144-F77A-48DF-B7C5-9B465734C36C}"/>
              </a:ext>
            </a:extLst>
          </p:cNvPr>
          <p:cNvSpPr txBox="1"/>
          <p:nvPr/>
        </p:nvSpPr>
        <p:spPr>
          <a:xfrm>
            <a:off x="5048929" y="3519600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CC7C9754-DA36-4EE8-BC47-722775726FC6}"/>
              </a:ext>
            </a:extLst>
          </p:cNvPr>
          <p:cNvSpPr txBox="1"/>
          <p:nvPr/>
        </p:nvSpPr>
        <p:spPr>
          <a:xfrm>
            <a:off x="3904952" y="351895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U87MG</a:t>
            </a:r>
          </a:p>
        </p:txBody>
      </p: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id="{6EA18D17-B13E-4C35-91DF-E8C8E69C0C51}"/>
              </a:ext>
            </a:extLst>
          </p:cNvPr>
          <p:cNvGrpSpPr/>
          <p:nvPr/>
        </p:nvGrpSpPr>
        <p:grpSpPr>
          <a:xfrm>
            <a:off x="3763323" y="3738476"/>
            <a:ext cx="1134048" cy="809315"/>
            <a:chOff x="936535" y="290821"/>
            <a:chExt cx="1134048" cy="809315"/>
          </a:xfrm>
        </p:grpSpPr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7F22740B-F86E-4EA2-B110-9951D16D7AF3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C8BBFC5D-AEAC-441F-9857-D4FA38FF3523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8F21C240-2584-44BF-91F6-0B65FDFBB0DB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0D647ADA-7ED6-4427-8063-AFD27F771EA4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461BD99D-264E-471B-87FE-F61BA2EDB23D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右大かっこ 225">
              <a:extLst>
                <a:ext uri="{FF2B5EF4-FFF2-40B4-BE49-F238E27FC236}">
                  <a16:creationId xmlns:a16="http://schemas.microsoft.com/office/drawing/2014/main" id="{F28A07E0-FEE4-46F7-8579-5FFFC47C972E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grpSp>
        <p:nvGrpSpPr>
          <p:cNvPr id="227" name="グループ化 226">
            <a:extLst>
              <a:ext uri="{FF2B5EF4-FFF2-40B4-BE49-F238E27FC236}">
                <a16:creationId xmlns:a16="http://schemas.microsoft.com/office/drawing/2014/main" id="{57A6AE84-0914-4525-8BAC-8C34D185C99B}"/>
              </a:ext>
            </a:extLst>
          </p:cNvPr>
          <p:cNvGrpSpPr/>
          <p:nvPr/>
        </p:nvGrpSpPr>
        <p:grpSpPr>
          <a:xfrm>
            <a:off x="4786357" y="3738476"/>
            <a:ext cx="1134048" cy="809315"/>
            <a:chOff x="936535" y="290821"/>
            <a:chExt cx="1134048" cy="809315"/>
          </a:xfrm>
        </p:grpSpPr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7D7BA8E4-0830-403C-8605-382574AB063E}"/>
                </a:ext>
              </a:extLst>
            </p:cNvPr>
            <p:cNvSpPr txBox="1"/>
            <p:nvPr/>
          </p:nvSpPr>
          <p:spPr>
            <a:xfrm rot="16200000">
              <a:off x="732312" y="641997"/>
              <a:ext cx="6623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テキスト ボックス 228">
              <a:extLst>
                <a:ext uri="{FF2B5EF4-FFF2-40B4-BE49-F238E27FC236}">
                  <a16:creationId xmlns:a16="http://schemas.microsoft.com/office/drawing/2014/main" id="{A4BCEFE7-80EE-44FA-9AEF-8D622F3965C1}"/>
                </a:ext>
              </a:extLst>
            </p:cNvPr>
            <p:cNvSpPr txBox="1"/>
            <p:nvPr/>
          </p:nvSpPr>
          <p:spPr>
            <a:xfrm>
              <a:off x="1116476" y="290821"/>
              <a:ext cx="95410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obenecid 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1 mM)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テキスト ボックス 229">
              <a:extLst>
                <a:ext uri="{FF2B5EF4-FFF2-40B4-BE49-F238E27FC236}">
                  <a16:creationId xmlns:a16="http://schemas.microsoft.com/office/drawing/2014/main" id="{2858C610-5A37-4D50-B4BA-F5EF26C6FDF9}"/>
                </a:ext>
              </a:extLst>
            </p:cNvPr>
            <p:cNvSpPr txBox="1"/>
            <p:nvPr/>
          </p:nvSpPr>
          <p:spPr>
            <a:xfrm rot="16200000">
              <a:off x="1123407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1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テキスト ボックス 230">
              <a:extLst>
                <a:ext uri="{FF2B5EF4-FFF2-40B4-BE49-F238E27FC236}">
                  <a16:creationId xmlns:a16="http://schemas.microsoft.com/office/drawing/2014/main" id="{20EEF284-97B8-4B93-9B80-87C89020500C}"/>
                </a:ext>
              </a:extLst>
            </p:cNvPr>
            <p:cNvSpPr txBox="1"/>
            <p:nvPr/>
          </p:nvSpPr>
          <p:spPr>
            <a:xfrm rot="16200000">
              <a:off x="137263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3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テキスト ボックス 231">
              <a:extLst>
                <a:ext uri="{FF2B5EF4-FFF2-40B4-BE49-F238E27FC236}">
                  <a16:creationId xmlns:a16="http://schemas.microsoft.com/office/drawing/2014/main" id="{310272A0-AD88-4D97-924D-5990A63CC3FF}"/>
                </a:ext>
              </a:extLst>
            </p:cNvPr>
            <p:cNvSpPr txBox="1"/>
            <p:nvPr/>
          </p:nvSpPr>
          <p:spPr>
            <a:xfrm rot="16200000">
              <a:off x="1621866" y="783863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右大かっこ 232">
              <a:extLst>
                <a:ext uri="{FF2B5EF4-FFF2-40B4-BE49-F238E27FC236}">
                  <a16:creationId xmlns:a16="http://schemas.microsoft.com/office/drawing/2014/main" id="{267F2366-49B3-4354-8777-A43D059FA3BA}"/>
                </a:ext>
              </a:extLst>
            </p:cNvPr>
            <p:cNvSpPr/>
            <p:nvPr/>
          </p:nvSpPr>
          <p:spPr>
            <a:xfrm rot="16200000">
              <a:off x="1536945" y="413731"/>
              <a:ext cx="45719" cy="648000"/>
            </a:xfrm>
            <a:prstGeom prst="righ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50"/>
            </a:p>
          </p:txBody>
        </p:sp>
      </p:grp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D7FB5701-BA54-4100-9552-EE1A82279BF3}"/>
              </a:ext>
            </a:extLst>
          </p:cNvPr>
          <p:cNvSpPr txBox="1"/>
          <p:nvPr/>
        </p:nvSpPr>
        <p:spPr>
          <a:xfrm>
            <a:off x="121768" y="51727"/>
            <a:ext cx="2316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sults of western blot (Cell lines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直線矢印コネクタ 237">
            <a:extLst>
              <a:ext uri="{FF2B5EF4-FFF2-40B4-BE49-F238E27FC236}">
                <a16:creationId xmlns:a16="http://schemas.microsoft.com/office/drawing/2014/main" id="{3E346C98-EBEB-4175-A5B1-C397B8B73243}"/>
              </a:ext>
            </a:extLst>
          </p:cNvPr>
          <p:cNvCxnSpPr>
            <a:cxnSpLocks/>
          </p:cNvCxnSpPr>
          <p:nvPr/>
        </p:nvCxnSpPr>
        <p:spPr>
          <a:xfrm flipH="1">
            <a:off x="3012659" y="2067560"/>
            <a:ext cx="2173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直線矢印コネクタ 238">
            <a:extLst>
              <a:ext uri="{FF2B5EF4-FFF2-40B4-BE49-F238E27FC236}">
                <a16:creationId xmlns:a16="http://schemas.microsoft.com/office/drawing/2014/main" id="{E7B10386-D0BF-4A7C-9440-2873E39C7361}"/>
              </a:ext>
            </a:extLst>
          </p:cNvPr>
          <p:cNvCxnSpPr>
            <a:cxnSpLocks/>
          </p:cNvCxnSpPr>
          <p:nvPr/>
        </p:nvCxnSpPr>
        <p:spPr>
          <a:xfrm flipH="1">
            <a:off x="6019558" y="2048510"/>
            <a:ext cx="2173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矢印コネクタ 239">
            <a:extLst>
              <a:ext uri="{FF2B5EF4-FFF2-40B4-BE49-F238E27FC236}">
                <a16:creationId xmlns:a16="http://schemas.microsoft.com/office/drawing/2014/main" id="{EDF5CABF-349E-4E2D-B30D-DBBADEF838C9}"/>
              </a:ext>
            </a:extLst>
          </p:cNvPr>
          <p:cNvCxnSpPr>
            <a:cxnSpLocks/>
          </p:cNvCxnSpPr>
          <p:nvPr/>
        </p:nvCxnSpPr>
        <p:spPr>
          <a:xfrm flipH="1">
            <a:off x="3253259" y="8616641"/>
            <a:ext cx="2173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直線矢印コネクタ 240">
            <a:extLst>
              <a:ext uri="{FF2B5EF4-FFF2-40B4-BE49-F238E27FC236}">
                <a16:creationId xmlns:a16="http://schemas.microsoft.com/office/drawing/2014/main" id="{209A071B-AC10-4C62-AB7C-AC67CEDCB6F8}"/>
              </a:ext>
            </a:extLst>
          </p:cNvPr>
          <p:cNvCxnSpPr>
            <a:cxnSpLocks/>
          </p:cNvCxnSpPr>
          <p:nvPr/>
        </p:nvCxnSpPr>
        <p:spPr>
          <a:xfrm flipH="1">
            <a:off x="5283974" y="8616641"/>
            <a:ext cx="2173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867110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BDBC124C-9708-4213-862E-8DA50393534A}"/>
              </a:ext>
            </a:extLst>
          </p:cNvPr>
          <p:cNvGraphicFramePr>
            <a:graphicFrameLocks/>
          </p:cNvGraphicFramePr>
          <p:nvPr/>
        </p:nvGraphicFramePr>
        <p:xfrm>
          <a:off x="678825" y="2136150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EA3EE277-005B-4292-9026-FAC937B00466}"/>
              </a:ext>
            </a:extLst>
          </p:cNvPr>
          <p:cNvGraphicFramePr>
            <a:graphicFrameLocks/>
          </p:cNvGraphicFramePr>
          <p:nvPr/>
        </p:nvGraphicFramePr>
        <p:xfrm>
          <a:off x="3517275" y="2136150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AC0E972B-1797-4166-B8A5-2358433AD3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5672436"/>
              </p:ext>
            </p:extLst>
          </p:nvPr>
        </p:nvGraphicFramePr>
        <p:xfrm>
          <a:off x="631200" y="5225425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83AAB16F-EAFC-49A4-B74E-20449B91EC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1589198"/>
              </p:ext>
            </p:extLst>
          </p:nvPr>
        </p:nvGraphicFramePr>
        <p:xfrm>
          <a:off x="3526800" y="5234950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4943632-1BEF-45AA-BC19-BE6AB8734668}"/>
              </a:ext>
            </a:extLst>
          </p:cNvPr>
          <p:cNvSpPr txBox="1"/>
          <p:nvPr/>
        </p:nvSpPr>
        <p:spPr>
          <a:xfrm>
            <a:off x="1868688" y="1794657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KOV3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9437A04-581A-467C-99E1-CDF208368D14}"/>
              </a:ext>
            </a:extLst>
          </p:cNvPr>
          <p:cNvSpPr txBox="1"/>
          <p:nvPr/>
        </p:nvSpPr>
        <p:spPr>
          <a:xfrm>
            <a:off x="4755114" y="5015513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06DFC73-148D-4D44-BFAE-C3408E47F752}"/>
              </a:ext>
            </a:extLst>
          </p:cNvPr>
          <p:cNvSpPr txBox="1"/>
          <p:nvPr/>
        </p:nvSpPr>
        <p:spPr>
          <a:xfrm>
            <a:off x="4668552" y="1794657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LS180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FB6B3B2-1490-43DC-8D31-BB174CC56FFA}"/>
              </a:ext>
            </a:extLst>
          </p:cNvPr>
          <p:cNvSpPr txBox="1"/>
          <p:nvPr/>
        </p:nvSpPr>
        <p:spPr>
          <a:xfrm>
            <a:off x="1821295" y="5015513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U87MG</a:t>
            </a:r>
          </a:p>
        </p:txBody>
      </p:sp>
    </p:spTree>
    <p:extLst>
      <p:ext uri="{BB962C8B-B14F-4D97-AF65-F5344CB8AC3E}">
        <p14:creationId xmlns:p14="http://schemas.microsoft.com/office/powerpoint/2010/main" val="1049015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</TotalTime>
  <Words>241</Words>
  <Application>Microsoft Office PowerPoint</Application>
  <PresentationFormat>A4 210 x 297 mm</PresentationFormat>
  <Paragraphs>10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島　康宏</dc:creator>
  <cp:lastModifiedBy>大島　康宏</cp:lastModifiedBy>
  <cp:revision>1</cp:revision>
  <dcterms:created xsi:type="dcterms:W3CDTF">2021-11-02T09:49:10Z</dcterms:created>
  <dcterms:modified xsi:type="dcterms:W3CDTF">2021-11-02T11:18:36Z</dcterms:modified>
</cp:coreProperties>
</file>